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4" r:id="rId8"/>
    <p:sldId id="265" r:id="rId9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79" d="100"/>
          <a:sy n="79" d="100"/>
        </p:scale>
        <p:origin x="-1620" y="-96"/>
      </p:cViewPr>
      <p:guideLst>
        <p:guide orient="horz" pos="2795"/>
        <p:guide orient="horz" pos="311"/>
        <p:guide pos="779"/>
        <p:guide pos="2200"/>
        <p:guide pos="3776"/>
        <p:guide pos="71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F903F7-7120-47E5-A482-639E0B5AAD9E}" type="datetimeFigureOut">
              <a:rPr lang="it-IT" smtClean="0"/>
              <a:pPr/>
              <a:t>31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5B9F6-6B77-4ABB-A48C-F7E416416128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7" Type="http://schemas.openxmlformats.org/officeDocument/2006/relationships/image" Target="../media/image6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wmf"/><Relationship Id="rId5" Type="http://schemas.openxmlformats.org/officeDocument/2006/relationships/image" Target="../media/image4.wmf"/><Relationship Id="rId4" Type="http://schemas.openxmlformats.org/officeDocument/2006/relationships/image" Target="../media/image3.w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wmf"/><Relationship Id="rId7" Type="http://schemas.openxmlformats.org/officeDocument/2006/relationships/image" Target="../media/image19.png"/><Relationship Id="rId2" Type="http://schemas.openxmlformats.org/officeDocument/2006/relationships/image" Target="../media/image14.w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61859" y="490960"/>
            <a:ext cx="2392903" cy="2162954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536615" y="480181"/>
            <a:ext cx="2392903" cy="2184513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</p:pic>
      <p:pic>
        <p:nvPicPr>
          <p:cNvPr id="6" name="Picture 1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336708" y="2664445"/>
            <a:ext cx="2443204" cy="2083909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511464" y="2639294"/>
            <a:ext cx="2443204" cy="2134211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</p:pic>
      <p:pic>
        <p:nvPicPr>
          <p:cNvPr id="8" name="Picture 1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376231" y="4736066"/>
            <a:ext cx="2364159" cy="2083909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592217" y="4631870"/>
            <a:ext cx="2364159" cy="2292300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</p:pic>
      <p:sp>
        <p:nvSpPr>
          <p:cNvPr id="10" name="CasellaDiTesto 9"/>
          <p:cNvSpPr txBox="1"/>
          <p:nvPr/>
        </p:nvSpPr>
        <p:spPr>
          <a:xfrm>
            <a:off x="3923928" y="1387771"/>
            <a:ext cx="1125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p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0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3923928" y="3521733"/>
            <a:ext cx="1125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p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6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3923928" y="559335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p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HLA-DR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1888094" y="179348"/>
            <a:ext cx="1340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RE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5997127" y="17934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OST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 rot="16200000">
            <a:off x="715248" y="1234961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 rot="16200000">
            <a:off x="715249" y="331174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 rot="16200000">
            <a:off x="715248" y="547198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 rot="16200000">
            <a:off x="4947085" y="1235550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4947086" y="331233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 rot="16200000">
            <a:off x="4947085" y="547257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52436" y="404664"/>
            <a:ext cx="6639127" cy="64533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CasellaDiTesto 4"/>
          <p:cNvSpPr txBox="1"/>
          <p:nvPr/>
        </p:nvSpPr>
        <p:spPr>
          <a:xfrm>
            <a:off x="3996120" y="1136776"/>
            <a:ext cx="1125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p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0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4010403" y="3239596"/>
            <a:ext cx="1125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p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6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3899864" y="5325272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p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HLA-DR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1888094" y="179348"/>
            <a:ext cx="1340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RE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6052450" y="17934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OST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 rot="16200000">
            <a:off x="782468" y="1234961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 rot="16200000">
            <a:off x="782469" y="331174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 rot="16200000">
            <a:off x="782468" y="547198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5049291" y="1235550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 rot="16200000">
            <a:off x="5049292" y="331233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 rot="16200000">
            <a:off x="5049291" y="547257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asellaDiTesto 9"/>
          <p:cNvSpPr txBox="1"/>
          <p:nvPr/>
        </p:nvSpPr>
        <p:spPr>
          <a:xfrm>
            <a:off x="1896772" y="179348"/>
            <a:ext cx="1340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RE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6335530" y="17934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OST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4211960" y="1387771"/>
            <a:ext cx="1188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>
                <a:latin typeface="Calibri" pitchFamily="34" charset="0"/>
              </a:rPr>
              <a:t>m</a:t>
            </a:r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0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4211960" y="3394873"/>
            <a:ext cx="1188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m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6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4211960" y="5555113"/>
            <a:ext cx="1401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m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HLA-DR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63663" y="493713"/>
            <a:ext cx="2406650" cy="21376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868144" y="493713"/>
            <a:ext cx="2406650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363663" y="2610809"/>
            <a:ext cx="2406650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868144" y="2610809"/>
            <a:ext cx="2406650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363663" y="4663447"/>
            <a:ext cx="2406650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868144" y="4663447"/>
            <a:ext cx="2406650" cy="21680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CasellaDiTesto 14"/>
          <p:cNvSpPr txBox="1"/>
          <p:nvPr/>
        </p:nvSpPr>
        <p:spPr>
          <a:xfrm rot="16200000">
            <a:off x="776755" y="1234961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 rot="16200000">
            <a:off x="776756" y="331174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 rot="16200000">
            <a:off x="776755" y="547198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 rot="16200000">
            <a:off x="5265315" y="1235550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5265316" y="331233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 rot="16200000">
            <a:off x="5265315" y="547257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63664" y="493714"/>
            <a:ext cx="2406650" cy="2179474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981774" y="493713"/>
            <a:ext cx="2396905" cy="2173287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4" cstate="print"/>
          <a:srcRect r="1331"/>
          <a:stretch>
            <a:fillRect/>
          </a:stretch>
        </p:blipFill>
        <p:spPr bwMode="auto">
          <a:xfrm>
            <a:off x="1363663" y="2564904"/>
            <a:ext cx="2374619" cy="2175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981774" y="2564904"/>
            <a:ext cx="2406650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6" cstate="print"/>
          <a:srcRect r="2349"/>
          <a:stretch>
            <a:fillRect/>
          </a:stretch>
        </p:blipFill>
        <p:spPr bwMode="auto">
          <a:xfrm>
            <a:off x="1363663" y="4653136"/>
            <a:ext cx="2347725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981774" y="4653136"/>
            <a:ext cx="2406650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CasellaDiTesto 13"/>
          <p:cNvSpPr txBox="1"/>
          <p:nvPr/>
        </p:nvSpPr>
        <p:spPr>
          <a:xfrm>
            <a:off x="1896772" y="179348"/>
            <a:ext cx="1340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RE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6335530" y="17934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OST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>
            <a:off x="4322782" y="1387771"/>
            <a:ext cx="1188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>
                <a:latin typeface="Calibri" pitchFamily="34" charset="0"/>
              </a:rPr>
              <a:t>m</a:t>
            </a:r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0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4322782" y="3394873"/>
            <a:ext cx="1188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m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6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4322782" y="5555113"/>
            <a:ext cx="1401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mDC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HLA-DR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842628" y="1234961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842629" y="331174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 rot="16200000">
            <a:off x="842628" y="547198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 rot="16200000">
            <a:off x="5379133" y="1235550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 rot="16200000">
            <a:off x="5379134" y="331233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 rot="16200000">
            <a:off x="5379133" y="547257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89195" y="493713"/>
            <a:ext cx="2406649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89194" y="2522742"/>
            <a:ext cx="2406650" cy="21751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989653" y="2522742"/>
            <a:ext cx="2412419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089194" y="4640089"/>
            <a:ext cx="2406650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989653" y="4640089"/>
            <a:ext cx="2406650" cy="2173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CasellaDiTesto 11"/>
          <p:cNvSpPr txBox="1"/>
          <p:nvPr/>
        </p:nvSpPr>
        <p:spPr>
          <a:xfrm>
            <a:off x="1622303" y="179348"/>
            <a:ext cx="1340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RE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6335530" y="17934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OST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3707904" y="1387771"/>
            <a:ext cx="17831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Calibri" pitchFamily="34" charset="0"/>
              </a:rPr>
              <a:t>Monocytes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0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3707904" y="3394873"/>
            <a:ext cx="17831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Monocytes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6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>
            <a:off x="3707904" y="5555113"/>
            <a:ext cx="1996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Monocytes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HLA-DR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994400" y="493713"/>
            <a:ext cx="2406650" cy="21431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CasellaDiTesto 16"/>
          <p:cNvSpPr txBox="1"/>
          <p:nvPr/>
        </p:nvSpPr>
        <p:spPr>
          <a:xfrm rot="16200000">
            <a:off x="482589" y="1234961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 rot="16200000">
            <a:off x="482590" y="331174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482589" y="547198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 rot="16200000">
            <a:off x="5379133" y="1235550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 rot="16200000">
            <a:off x="5379134" y="331233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 rot="16200000">
            <a:off x="5379133" y="547257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 r="1684"/>
          <a:stretch>
            <a:fillRect/>
          </a:stretch>
        </p:blipFill>
        <p:spPr bwMode="auto">
          <a:xfrm>
            <a:off x="1017186" y="493713"/>
            <a:ext cx="2366126" cy="2143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985542" y="493713"/>
            <a:ext cx="2365958" cy="2143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 cstate="print"/>
          <a:srcRect r="2184"/>
          <a:stretch>
            <a:fillRect/>
          </a:stretch>
        </p:blipFill>
        <p:spPr bwMode="auto">
          <a:xfrm>
            <a:off x="1017186" y="2636838"/>
            <a:ext cx="2354095" cy="2143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985542" y="2636838"/>
            <a:ext cx="2406650" cy="2143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6" cstate="print"/>
          <a:srcRect r="1684"/>
          <a:stretch>
            <a:fillRect/>
          </a:stretch>
        </p:blipFill>
        <p:spPr bwMode="auto">
          <a:xfrm>
            <a:off x="1017186" y="4714875"/>
            <a:ext cx="2366126" cy="2143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8" name="Picture 8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985542" y="4714875"/>
            <a:ext cx="2406650" cy="2143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CasellaDiTesto 10"/>
          <p:cNvSpPr txBox="1"/>
          <p:nvPr/>
        </p:nvSpPr>
        <p:spPr>
          <a:xfrm>
            <a:off x="1550295" y="179348"/>
            <a:ext cx="1340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RE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6335530" y="17934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POST-CHEMO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3655804" y="1387771"/>
            <a:ext cx="17831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Calibri" pitchFamily="34" charset="0"/>
              </a:rPr>
              <a:t>Monocytes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0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3655804" y="3394873"/>
            <a:ext cx="17831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Monocytes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CD86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3655804" y="5555113"/>
            <a:ext cx="1996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chemeClr val="tx1"/>
                </a:solidFill>
                <a:latin typeface="Calibri" pitchFamily="34" charset="0"/>
              </a:rPr>
              <a:t>Monocytes</a:t>
            </a:r>
            <a:r>
              <a:rPr lang="it-IT" dirty="0" smtClean="0">
                <a:solidFill>
                  <a:schemeClr val="tx1"/>
                </a:solidFill>
                <a:latin typeface="Calibri" pitchFamily="34" charset="0"/>
              </a:rPr>
              <a:t> HLA-DR</a:t>
            </a:r>
            <a:endParaRPr lang="it-IT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 rot="16200000">
            <a:off x="482589" y="1234961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 rot="16200000">
            <a:off x="482590" y="331174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 rot="16200000">
            <a:off x="482589" y="5471989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5379133" y="1235550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 rot="16200000">
            <a:off x="5379134" y="331233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 rot="16200000">
            <a:off x="5379133" y="5472578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% positive </a:t>
            </a:r>
            <a:r>
              <a:rPr lang="it-IT" sz="1000" b="1" dirty="0" err="1" smtClean="0">
                <a:solidFill>
                  <a:schemeClr val="tx1"/>
                </a:solidFill>
                <a:latin typeface="Calibri" pitchFamily="34" charset="0"/>
              </a:rPr>
              <a:t>cells</a:t>
            </a:r>
            <a:r>
              <a:rPr lang="it-IT" sz="1000" b="1" dirty="0" smtClean="0">
                <a:solidFill>
                  <a:schemeClr val="tx1"/>
                </a:solidFill>
                <a:latin typeface="Calibri" pitchFamily="34" charset="0"/>
              </a:rPr>
              <a:t> </a:t>
            </a:r>
            <a:endParaRPr lang="it-IT" sz="1000" b="1" dirty="0">
              <a:solidFill>
                <a:schemeClr val="tx1"/>
              </a:solidFill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 l="1561" t="2590" r="1561" b="2238"/>
          <a:stretch>
            <a:fillRect/>
          </a:stretch>
        </p:blipFill>
        <p:spPr bwMode="auto">
          <a:xfrm>
            <a:off x="539552" y="908720"/>
            <a:ext cx="8064896" cy="38164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" name="Connettore 1 3"/>
          <p:cNvCxnSpPr/>
          <p:nvPr/>
        </p:nvCxnSpPr>
        <p:spPr>
          <a:xfrm>
            <a:off x="1043608" y="4797425"/>
            <a:ext cx="1512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nettore 1 4"/>
          <p:cNvCxnSpPr/>
          <p:nvPr/>
        </p:nvCxnSpPr>
        <p:spPr>
          <a:xfrm>
            <a:off x="2737892" y="4797152"/>
            <a:ext cx="1512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ttore 1 5"/>
          <p:cNvCxnSpPr/>
          <p:nvPr/>
        </p:nvCxnSpPr>
        <p:spPr>
          <a:xfrm>
            <a:off x="4427984" y="4803502"/>
            <a:ext cx="1512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ttore 1 6"/>
          <p:cNvCxnSpPr/>
          <p:nvPr/>
        </p:nvCxnSpPr>
        <p:spPr>
          <a:xfrm>
            <a:off x="6122268" y="4803502"/>
            <a:ext cx="1512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sellaDiTesto 7"/>
          <p:cNvSpPr txBox="1"/>
          <p:nvPr/>
        </p:nvSpPr>
        <p:spPr>
          <a:xfrm>
            <a:off x="1410804" y="4869160"/>
            <a:ext cx="77777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100" spc="-70" dirty="0" err="1" smtClean="0">
                <a:solidFill>
                  <a:schemeClr val="tx1"/>
                </a:solidFill>
                <a:latin typeface="Calibri" pitchFamily="34" charset="0"/>
              </a:rPr>
              <a:t>RNAdjuvant</a:t>
            </a:r>
            <a:endParaRPr lang="it-IT" sz="1100" spc="-70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3190047" y="4869160"/>
            <a:ext cx="607859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100" dirty="0" err="1" smtClean="0">
                <a:solidFill>
                  <a:schemeClr val="tx1"/>
                </a:solidFill>
                <a:latin typeface="Calibri" pitchFamily="34" charset="0"/>
              </a:rPr>
              <a:t>Poly</a:t>
            </a:r>
            <a:r>
              <a:rPr lang="it-IT" sz="1100" dirty="0" smtClean="0">
                <a:solidFill>
                  <a:schemeClr val="tx1"/>
                </a:solidFill>
                <a:latin typeface="Calibri" pitchFamily="34" charset="0"/>
              </a:rPr>
              <a:t> I:C</a:t>
            </a:r>
            <a:endParaRPr lang="it-IT" sz="1100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4913701" y="4869160"/>
            <a:ext cx="54073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Calibri" pitchFamily="34" charset="0"/>
              </a:rPr>
              <a:t>IMQ</a:t>
            </a:r>
            <a:endParaRPr lang="it-IT" sz="1100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6554316" y="4869160"/>
            <a:ext cx="64807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 smtClean="0">
                <a:solidFill>
                  <a:schemeClr val="tx1"/>
                </a:solidFill>
                <a:latin typeface="Calibri" pitchFamily="34" charset="0"/>
              </a:rPr>
              <a:t>CpG</a:t>
            </a:r>
            <a:endParaRPr lang="it-IT" sz="1100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 rot="16200000">
            <a:off x="148446" y="2369715"/>
            <a:ext cx="57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/>
              <a:t>p</a:t>
            </a:r>
            <a:r>
              <a:rPr lang="it-IT" sz="1200" b="1" dirty="0" err="1" smtClean="0"/>
              <a:t>g</a:t>
            </a:r>
            <a:r>
              <a:rPr lang="it-IT" sz="1200" b="1" dirty="0" smtClean="0"/>
              <a:t>/ml</a:t>
            </a:r>
            <a:endParaRPr lang="it-IT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l="713" t="1608" r="1292" b="1538"/>
          <a:stretch>
            <a:fillRect/>
          </a:stretch>
        </p:blipFill>
        <p:spPr bwMode="auto">
          <a:xfrm>
            <a:off x="312821" y="908720"/>
            <a:ext cx="8435643" cy="34587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CasellaDiTesto 8"/>
          <p:cNvSpPr txBox="1"/>
          <p:nvPr/>
        </p:nvSpPr>
        <p:spPr>
          <a:xfrm>
            <a:off x="1230784" y="4463534"/>
            <a:ext cx="777777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100" spc="-70" dirty="0" err="1" smtClean="0">
                <a:solidFill>
                  <a:schemeClr val="tx1"/>
                </a:solidFill>
                <a:latin typeface="Calibri" pitchFamily="34" charset="0"/>
              </a:rPr>
              <a:t>RNAdjuvant</a:t>
            </a:r>
            <a:endParaRPr lang="it-IT" sz="1100" spc="-70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3168901" y="4463534"/>
            <a:ext cx="607859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100" dirty="0" err="1" smtClean="0">
                <a:solidFill>
                  <a:schemeClr val="tx1"/>
                </a:solidFill>
                <a:latin typeface="Calibri" pitchFamily="34" charset="0"/>
              </a:rPr>
              <a:t>Poly</a:t>
            </a:r>
            <a:r>
              <a:rPr lang="it-IT" sz="1100" dirty="0" smtClean="0">
                <a:solidFill>
                  <a:schemeClr val="tx1"/>
                </a:solidFill>
                <a:latin typeface="Calibri" pitchFamily="34" charset="0"/>
              </a:rPr>
              <a:t> I:C</a:t>
            </a:r>
            <a:endParaRPr lang="it-IT" sz="1100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5056787" y="4463534"/>
            <a:ext cx="54073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Calibri" pitchFamily="34" charset="0"/>
              </a:rPr>
              <a:t>IMQ</a:t>
            </a:r>
            <a:endParaRPr lang="it-IT" sz="1100" dirty="0">
              <a:solidFill>
                <a:schemeClr val="tx1"/>
              </a:solidFill>
              <a:latin typeface="Calibri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6839173" y="4463534"/>
            <a:ext cx="64807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sz="1100" dirty="0" err="1" smtClean="0">
                <a:solidFill>
                  <a:schemeClr val="tx1"/>
                </a:solidFill>
                <a:latin typeface="Calibri" pitchFamily="34" charset="0"/>
              </a:rPr>
              <a:t>CpG</a:t>
            </a:r>
            <a:endParaRPr lang="it-IT" sz="1100" dirty="0">
              <a:solidFill>
                <a:schemeClr val="tx1"/>
              </a:solidFill>
              <a:latin typeface="Calibri" pitchFamily="34" charset="0"/>
            </a:endParaRPr>
          </a:p>
        </p:txBody>
      </p:sp>
      <p:cxnSp>
        <p:nvCxnSpPr>
          <p:cNvPr id="20" name="Connettore 1 19"/>
          <p:cNvCxnSpPr/>
          <p:nvPr/>
        </p:nvCxnSpPr>
        <p:spPr>
          <a:xfrm>
            <a:off x="755576" y="4403725"/>
            <a:ext cx="172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ttore 1 20"/>
          <p:cNvCxnSpPr/>
          <p:nvPr/>
        </p:nvCxnSpPr>
        <p:spPr>
          <a:xfrm>
            <a:off x="4463058" y="4397375"/>
            <a:ext cx="172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ttore 1 21"/>
          <p:cNvCxnSpPr/>
          <p:nvPr/>
        </p:nvCxnSpPr>
        <p:spPr>
          <a:xfrm>
            <a:off x="6299113" y="4399806"/>
            <a:ext cx="172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1 22"/>
          <p:cNvCxnSpPr/>
          <p:nvPr/>
        </p:nvCxnSpPr>
        <p:spPr>
          <a:xfrm>
            <a:off x="2608734" y="4401840"/>
            <a:ext cx="1728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sellaDiTesto 12"/>
          <p:cNvSpPr txBox="1"/>
          <p:nvPr/>
        </p:nvSpPr>
        <p:spPr>
          <a:xfrm rot="16200000">
            <a:off x="41305" y="2369715"/>
            <a:ext cx="57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/>
              <a:t>p</a:t>
            </a:r>
            <a:r>
              <a:rPr lang="it-IT" sz="1200" b="1" dirty="0" err="1" smtClean="0"/>
              <a:t>g</a:t>
            </a:r>
            <a:r>
              <a:rPr lang="it-IT" sz="1200" b="1" dirty="0" smtClean="0"/>
              <a:t>/ml</a:t>
            </a:r>
            <a:endParaRPr lang="it-IT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1</TotalTime>
  <Words>168</Words>
  <Application>Microsoft Office PowerPoint</Application>
  <PresentationFormat>Presentazione su schermo (4:3)</PresentationFormat>
  <Paragraphs>76</Paragraphs>
  <Slides>8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8</vt:i4>
      </vt:variant>
    </vt:vector>
  </HeadingPairs>
  <TitlesOfParts>
    <vt:vector size="9" baseType="lpstr">
      <vt:lpstr>Tema di Offic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  <vt:lpstr>Diapositiva 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uigi</dc:creator>
  <cp:lastModifiedBy>Luigi</cp:lastModifiedBy>
  <cp:revision>77</cp:revision>
  <dcterms:created xsi:type="dcterms:W3CDTF">2019-07-03T11:45:36Z</dcterms:created>
  <dcterms:modified xsi:type="dcterms:W3CDTF">2019-07-31T14:43:49Z</dcterms:modified>
</cp:coreProperties>
</file>